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83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一燈 下川" userId="eb6a0abbb11b9709" providerId="LiveId" clId="{DE6B5929-98A7-4ED5-98E4-DD4BA1C6C573}"/>
    <pc:docChg chg="modSld">
      <pc:chgData name="一燈 下川" userId="eb6a0abbb11b9709" providerId="LiveId" clId="{DE6B5929-98A7-4ED5-98E4-DD4BA1C6C573}" dt="2025-03-26T05:20:44.310" v="8" actId="1076"/>
      <pc:docMkLst>
        <pc:docMk/>
      </pc:docMkLst>
      <pc:sldChg chg="addSp modSp mod">
        <pc:chgData name="一燈 下川" userId="eb6a0abbb11b9709" providerId="LiveId" clId="{DE6B5929-98A7-4ED5-98E4-DD4BA1C6C573}" dt="2025-03-26T05:20:44.310" v="8" actId="1076"/>
        <pc:sldMkLst>
          <pc:docMk/>
          <pc:sldMk cId="608900236" sldId="256"/>
        </pc:sldMkLst>
        <pc:spChg chg="add mod">
          <ac:chgData name="一燈 下川" userId="eb6a0abbb11b9709" providerId="LiveId" clId="{DE6B5929-98A7-4ED5-98E4-DD4BA1C6C573}" dt="2025-03-26T05:20:44.310" v="8" actId="1076"/>
          <ac:spMkLst>
            <pc:docMk/>
            <pc:sldMk cId="608900236" sldId="256"/>
            <ac:spMk id="3" creationId="{D35B3186-1562-4B82-B833-F64FAA4DCFEC}"/>
          </ac:spMkLst>
        </pc:spChg>
        <pc:picChg chg="mod">
          <ac:chgData name="一燈 下川" userId="eb6a0abbb11b9709" providerId="LiveId" clId="{DE6B5929-98A7-4ED5-98E4-DD4BA1C6C573}" dt="2025-03-26T05:19:49.228" v="2" actId="14100"/>
          <ac:picMkLst>
            <pc:docMk/>
            <pc:sldMk cId="608900236" sldId="256"/>
            <ac:picMk id="5" creationId="{D3623D2F-B80C-A930-5CAA-3E57AD22827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3D900E-42A1-1F2B-E343-84FA45A202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932479A-78C0-3201-AA13-FBEB572FD8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5515C3C-CC1A-9242-4991-D2371B054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237511-6034-1E68-ED11-5FA91F877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428957-11BA-BA74-7F3C-5F8D36D536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237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B9FE21-DC4C-8F86-3E2A-5F6AD73F2B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ABA1B43-1508-72DF-0C63-04076A3634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03C2CB-A035-3110-1036-CF41F53C6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5E1C3E-DB78-36B3-22F3-D94DC1A67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F26836-6390-FF64-8186-BA12D59F4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182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BDE54F5-B0AB-BD1C-8C56-7F4D84FBE3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005B662-3872-F477-1EA4-13EF1960E0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F72EF4-2E18-21E9-C6ED-F8DC58BC1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BD2ACA-5B3C-83C0-50A7-8485DD802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24C443-4981-9A8B-1C72-EC803D8BD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265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F3C379-35CE-6526-91D4-C5445D79C4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07BFEB1-5645-11E9-A028-A5ABF1C701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A6E4E9-A6FA-E285-7F1A-66EB67E59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BD9E24-750E-D6BB-601A-E51CE05C5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75ED65-F62C-A193-8C58-F9FD9EA6A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9013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FBD887-95C7-856E-EB5F-CA3198735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5424D29-4772-39A2-B8C7-CEDEC381F9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6F3D5E-0BB1-628E-B18E-263FE2E6F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357C6A-FE2C-710D-C2C8-F052D1CBB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7812B6-719A-3D17-A91B-17D45B1F5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6442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6379C8-21E5-E05B-5C24-060927D08C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779AD0C-22EE-DA27-CFC5-549C7ACBBF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4AE2F7C-64ED-C64F-E888-2FA794AB9E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4A28C6E-585C-F5FA-577A-16CAA42F2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3B6DE66-FB42-1D8C-3A57-3C11B594D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55C5EAB-F14B-9E08-8B1A-7C5AE446F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518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C6924A-FB81-319C-07E5-18AF45E27C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7F3EDA1-B2DD-57B0-18AE-75E3B103F1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12467BC-5447-A254-EFCA-09EAC2AB16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7123AC4-EF9B-A22E-E95E-2646AFCBC2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4E1BFDC-D99D-C32A-DA3B-D04113D6F4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16A5E90-56A2-5000-932A-BFCA9524DE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6C37B2E-9275-F73F-7834-594255434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F87E10A-BEA6-B329-8C97-E27BC540B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29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5DCC4E-BFE6-9900-7796-CEC1CB7C8A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81B2D33-B7E1-5836-90EA-6FD28AA8B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3A4BB74-C075-9830-C81A-161AC8073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31D705D-3310-AE51-B235-C6EA18723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5915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E11DC20-2094-D303-3328-4DE0165DA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F23FA5C-6BF3-419F-EEAD-9347D9D5B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2E37CC2-5E23-2DC5-FC37-1235544A0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089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4FB291-EAFF-0E70-7EF2-C06125F0DC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9210199-C09D-4BAB-0319-9D936D1558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16AE7EF-9671-0873-A28C-2850A57731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ED1523B-C74D-6936-84B8-EF0CAE27F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D4C068-5A3C-5359-459A-CCD14C34F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D381D1B-4560-DD4E-E414-B850929A9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70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CBAA1E-1C58-8BB2-F6FA-D590C48AC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8AB450C-E575-221D-408F-B37A2CE9FA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B59ADBE-2F2F-A87A-BD6B-8A77B949C7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344638E-28AA-A6D8-138A-6F3237D26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AC410A-0B72-DAA1-8253-2886D1D87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4A1A8B-5857-27E7-475F-FAF291F2C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664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DD0B68B-6515-F2C0-CE52-D93D6B72A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C92CC7-FFB4-A159-D4EC-651366AAEC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206C25-2B8B-66A0-7EA6-F7F4A5DBBA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DC0709-9B7B-4AEC-9A8A-D58F07EB7D61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D8B182-90B2-20AA-EA9E-CACAD229F3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6BF2B0-F72B-5721-8C69-E4BE8C4BE5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FC89FE-DD54-45B9-B4A7-A4D26FA5A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080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D3623D2F-B80C-A930-5CAA-3E57AD2282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4608" y="101326"/>
            <a:ext cx="7787653" cy="519826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35B3186-1562-4B82-B833-F64FAA4DCFEC}"/>
              </a:ext>
            </a:extLst>
          </p:cNvPr>
          <p:cNvSpPr txBox="1"/>
          <p:nvPr/>
        </p:nvSpPr>
        <p:spPr>
          <a:xfrm>
            <a:off x="1297859" y="5556525"/>
            <a:ext cx="107663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ry Figure S1</a:t>
            </a:r>
            <a:r>
              <a:rPr lang="en-US" altLang="ja-JP" sz="18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PR curve of the YOLOv5x model with both benign and </a:t>
            </a:r>
            <a:r>
              <a:rPr lang="en-US" altLang="ja-JP" sz="1800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lignat</a:t>
            </a:r>
            <a:r>
              <a:rPr lang="en-US" altLang="ja-JP" sz="18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nnotations. 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08900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1</TotalTime>
  <Words>17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一燈 下川</dc:creator>
  <cp:lastModifiedBy>一燈 下川</cp:lastModifiedBy>
  <cp:revision>1</cp:revision>
  <dcterms:created xsi:type="dcterms:W3CDTF">2024-10-30T06:08:46Z</dcterms:created>
  <dcterms:modified xsi:type="dcterms:W3CDTF">2025-03-26T05:20:46Z</dcterms:modified>
</cp:coreProperties>
</file>